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64963-3F95-49F6-A52F-4BFBBAAECD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E83C2-494B-40D9-8638-5C5620E598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2F0FA-5638-4AE7-9809-DFA5E0CF57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A02C5-F3D4-4BD1-AE38-501ECA81F8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46B507-FB75-4AFF-950C-2DB3DA79F8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922A6-5E5B-4D67-BAD5-8C2680EBED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4D199-F959-4544-B746-C9ACC3BE68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3C390-4426-4754-972A-C1A31DDE8D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2D577-54DB-4F85-A897-C98A7550FE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C5D9F1-3CD5-4B6E-BF22-F1E0AACBA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C926B-2C14-4D80-9058-1E8E30A45B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C3F8F-6AC9-4C01-87F0-1418E0FBD6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187BCF-5E1B-40B0-B9C7-82D709A296B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88640" y="54000"/>
            <a:ext cx="6553440" cy="7616520"/>
            <a:chOff x="188640" y="54000"/>
            <a:chExt cx="6553440" cy="7616520"/>
          </a:xfrm>
        </p:grpSpPr>
        <p:sp>
          <p:nvSpPr>
            <p:cNvPr id="42" name=""/>
            <p:cNvSpPr/>
            <p:nvPr/>
          </p:nvSpPr>
          <p:spPr>
            <a:xfrm>
              <a:off x="529920" y="3873960"/>
              <a:ext cx="892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G-CS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539000" y="3873960"/>
              <a:ext cx="89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CP-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286080" y="3873960"/>
              <a:ext cx="922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800" spc="-1" strike="noStrike">
                  <a:solidFill>
                    <a:srgbClr val="000000"/>
                  </a:solidFill>
                  <a:latin typeface="Arial"/>
                </a:rPr>
                <a:t>MIP-1</a:t>
              </a:r>
              <a:r>
                <a:rPr b="0" lang="el-GR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73200" y="3873960"/>
              <a:ext cx="904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-CS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630440" y="6037920"/>
              <a:ext cx="726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IP-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66720" y="5604480"/>
              <a:ext cx="184320" cy="36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63160" y="5604480"/>
              <a:ext cx="237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CXCR3 Chemokin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60280" y="5481720"/>
              <a:ext cx="2349720" cy="989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"/>
            <p:cNvGrpSpPr/>
            <p:nvPr/>
          </p:nvGrpSpPr>
          <p:grpSpPr>
            <a:xfrm>
              <a:off x="1563120" y="1151640"/>
              <a:ext cx="3167280" cy="739080"/>
              <a:chOff x="1563120" y="1151640"/>
              <a:chExt cx="3167280" cy="739080"/>
            </a:xfrm>
          </p:grpSpPr>
          <p:sp>
            <p:nvSpPr>
              <p:cNvPr id="51" name=""/>
              <p:cNvSpPr/>
              <p:nvPr/>
            </p:nvSpPr>
            <p:spPr>
              <a:xfrm>
                <a:off x="1563120" y="1151640"/>
                <a:ext cx="758160" cy="368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</a:rPr>
                  <a:t>TNF</a:t>
                </a:r>
                <a:r>
                  <a:rPr b="0" lang="el-GR" sz="1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156560" y="1151640"/>
                <a:ext cx="573840" cy="368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IL-6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788200" y="1522440"/>
                <a:ext cx="700560" cy="368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IL-2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1557360" y="780480"/>
              <a:ext cx="3166920" cy="36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Upstream IL-17 Regulator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413000" y="780480"/>
              <a:ext cx="3600360" cy="11754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"/>
            <p:cNvGrpSpPr/>
            <p:nvPr/>
          </p:nvGrpSpPr>
          <p:grpSpPr>
            <a:xfrm>
              <a:off x="2708280" y="1461240"/>
              <a:ext cx="936720" cy="1112400"/>
              <a:chOff x="2708280" y="1461240"/>
              <a:chExt cx="936720" cy="1112400"/>
            </a:xfrm>
          </p:grpSpPr>
          <p:sp>
            <p:nvSpPr>
              <p:cNvPr id="57" name=""/>
              <p:cNvSpPr/>
              <p:nvPr/>
            </p:nvSpPr>
            <p:spPr>
              <a:xfrm>
                <a:off x="2783520" y="2202840"/>
                <a:ext cx="700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IL-17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708280" y="1461240"/>
                <a:ext cx="936720" cy="1112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141720" y="1770480"/>
                <a:ext cx="0" cy="49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"/>
            <p:cNvSpPr/>
            <p:nvPr/>
          </p:nvSpPr>
          <p:spPr>
            <a:xfrm>
              <a:off x="2349360" y="1461240"/>
              <a:ext cx="574920" cy="55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3429000" y="1461240"/>
              <a:ext cx="720720" cy="55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141720" y="2512800"/>
              <a:ext cx="0" cy="49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265640" y="2079000"/>
              <a:ext cx="213984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Pro-inflammatory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cytokin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221000" y="2079000"/>
              <a:ext cx="2184480" cy="1299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3141720" y="2822400"/>
              <a:ext cx="1727280" cy="18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"/>
            <p:cNvGrpSpPr/>
            <p:nvPr/>
          </p:nvGrpSpPr>
          <p:grpSpPr>
            <a:xfrm>
              <a:off x="4949280" y="2635560"/>
              <a:ext cx="770400" cy="1693080"/>
              <a:chOff x="4949280" y="2635560"/>
              <a:chExt cx="770400" cy="1693080"/>
            </a:xfrm>
          </p:grpSpPr>
          <p:grpSp>
            <p:nvGrpSpPr>
              <p:cNvPr id="67" name=""/>
              <p:cNvGrpSpPr/>
              <p:nvPr/>
            </p:nvGrpSpPr>
            <p:grpSpPr>
              <a:xfrm>
                <a:off x="4949280" y="2635560"/>
                <a:ext cx="770400" cy="740160"/>
                <a:chOff x="4949280" y="2635560"/>
                <a:chExt cx="770400" cy="740160"/>
              </a:xfrm>
            </p:grpSpPr>
            <p:sp>
              <p:nvSpPr>
                <p:cNvPr id="68" name=""/>
                <p:cNvSpPr/>
                <p:nvPr/>
              </p:nvSpPr>
              <p:spPr>
                <a:xfrm>
                  <a:off x="4949280" y="2635560"/>
                  <a:ext cx="7704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CA" sz="1800" spc="-1" strike="noStrike">
                      <a:solidFill>
                        <a:srgbClr val="000000"/>
                      </a:solidFill>
                      <a:latin typeface="Arial"/>
                    </a:rPr>
                    <a:t>IL-1 </a:t>
                  </a:r>
                  <a:r>
                    <a:rPr b="0" lang="el-GR" sz="1800" spc="-1" strike="noStrike">
                      <a:solidFill>
                        <a:srgbClr val="000000"/>
                      </a:solidFill>
                      <a:latin typeface="Arial"/>
                    </a:rPr>
                    <a:t>α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4985280" y="3007440"/>
                  <a:ext cx="7005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CA" sz="1800" spc="-1" strike="noStrike">
                      <a:solidFill>
                        <a:srgbClr val="000000"/>
                      </a:solidFill>
                      <a:latin typeface="Arial"/>
                    </a:rPr>
                    <a:t>IL-17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0" name=""/>
              <p:cNvGrpSpPr/>
              <p:nvPr/>
            </p:nvGrpSpPr>
            <p:grpSpPr>
              <a:xfrm>
                <a:off x="5043240" y="3564000"/>
                <a:ext cx="583920" cy="764640"/>
                <a:chOff x="5043240" y="3564000"/>
                <a:chExt cx="583920" cy="764640"/>
              </a:xfrm>
            </p:grpSpPr>
            <p:sp>
              <p:nvSpPr>
                <p:cNvPr id="71" name=""/>
                <p:cNvSpPr/>
                <p:nvPr/>
              </p:nvSpPr>
              <p:spPr>
                <a:xfrm>
                  <a:off x="5043240" y="3564000"/>
                  <a:ext cx="5738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IL-6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5077440" y="3960360"/>
                  <a:ext cx="5497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LIF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3" name=""/>
            <p:cNvSpPr/>
            <p:nvPr/>
          </p:nvSpPr>
          <p:spPr>
            <a:xfrm>
              <a:off x="4221000" y="3378600"/>
              <a:ext cx="2184480" cy="10512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H="1">
              <a:off x="4723920" y="1337040"/>
              <a:ext cx="180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141720" y="3007440"/>
              <a:ext cx="1800000" cy="86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" name=""/>
            <p:cNvGrpSpPr/>
            <p:nvPr/>
          </p:nvGrpSpPr>
          <p:grpSpPr>
            <a:xfrm>
              <a:off x="333360" y="2017800"/>
              <a:ext cx="1871640" cy="1003320"/>
              <a:chOff x="333360" y="2017800"/>
              <a:chExt cx="1871640" cy="1003320"/>
            </a:xfrm>
          </p:grpSpPr>
          <p:sp>
            <p:nvSpPr>
              <p:cNvPr id="77" name=""/>
              <p:cNvSpPr/>
              <p:nvPr/>
            </p:nvSpPr>
            <p:spPr>
              <a:xfrm>
                <a:off x="962280" y="2346120"/>
                <a:ext cx="5738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IL-5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962640" y="2652840"/>
                <a:ext cx="7005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IL-13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06800" y="2017800"/>
                <a:ext cx="1640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Th2 Effector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33360" y="2017800"/>
                <a:ext cx="1871640" cy="990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" name=""/>
            <p:cNvSpPr/>
            <p:nvPr/>
          </p:nvSpPr>
          <p:spPr>
            <a:xfrm>
              <a:off x="3141720" y="3007440"/>
              <a:ext cx="574560" cy="86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H="1">
              <a:off x="2997000" y="3007440"/>
              <a:ext cx="144360" cy="86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1989000" y="3007440"/>
              <a:ext cx="1152720" cy="86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981000" y="3007440"/>
              <a:ext cx="2160720" cy="86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5" name=""/>
            <p:cNvGrpSpPr/>
            <p:nvPr/>
          </p:nvGrpSpPr>
          <p:grpSpPr>
            <a:xfrm>
              <a:off x="6524640" y="1337040"/>
              <a:ext cx="0" cy="2412360"/>
              <a:chOff x="6524640" y="1337040"/>
              <a:chExt cx="0" cy="2412360"/>
            </a:xfrm>
          </p:grpSpPr>
          <p:sp>
            <p:nvSpPr>
              <p:cNvPr id="86" name=""/>
              <p:cNvSpPr/>
              <p:nvPr/>
            </p:nvSpPr>
            <p:spPr>
              <a:xfrm flipV="1">
                <a:off x="6524640" y="2543400"/>
                <a:ext cx="0" cy="120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V="1">
                <a:off x="6524640" y="1337040"/>
                <a:ext cx="0" cy="1207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"/>
            <p:cNvSpPr/>
            <p:nvPr/>
          </p:nvSpPr>
          <p:spPr>
            <a:xfrm>
              <a:off x="2864520" y="54000"/>
              <a:ext cx="552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E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139920" y="409680"/>
              <a:ext cx="0" cy="307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141720" y="3007440"/>
              <a:ext cx="1727280" cy="12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213000" y="5236200"/>
              <a:ext cx="3422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Chemoattractant Chemokin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968560" y="5172120"/>
              <a:ext cx="3773520" cy="13608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" name=""/>
            <p:cNvGrpSpPr/>
            <p:nvPr/>
          </p:nvGrpSpPr>
          <p:grpSpPr>
            <a:xfrm>
              <a:off x="3165480" y="5542920"/>
              <a:ext cx="3439080" cy="1914480"/>
              <a:chOff x="3165480" y="5542920"/>
              <a:chExt cx="3439080" cy="1914480"/>
            </a:xfrm>
          </p:grpSpPr>
          <p:grpSp>
            <p:nvGrpSpPr>
              <p:cNvPr id="94" name=""/>
              <p:cNvGrpSpPr/>
              <p:nvPr/>
            </p:nvGrpSpPr>
            <p:grpSpPr>
              <a:xfrm>
                <a:off x="3165480" y="5544000"/>
                <a:ext cx="790200" cy="1484640"/>
                <a:chOff x="3165480" y="5544000"/>
                <a:chExt cx="790200" cy="1484640"/>
              </a:xfrm>
            </p:grpSpPr>
            <p:sp>
              <p:nvSpPr>
                <p:cNvPr id="95" name=""/>
                <p:cNvSpPr/>
                <p:nvPr/>
              </p:nvSpPr>
              <p:spPr>
                <a:xfrm>
                  <a:off x="3165480" y="5544000"/>
                  <a:ext cx="79020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MIP-2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3560760" y="5853240"/>
                  <a:ext cx="0" cy="1175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" name=""/>
              <p:cNvGrpSpPr/>
              <p:nvPr/>
            </p:nvGrpSpPr>
            <p:grpSpPr>
              <a:xfrm>
                <a:off x="5347080" y="5544000"/>
                <a:ext cx="1257480" cy="1484640"/>
                <a:chOff x="5347080" y="5544000"/>
                <a:chExt cx="1257480" cy="1484640"/>
              </a:xfrm>
            </p:grpSpPr>
            <p:sp>
              <p:nvSpPr>
                <p:cNvPr id="98" name=""/>
                <p:cNvSpPr/>
                <p:nvPr/>
              </p:nvSpPr>
              <p:spPr>
                <a:xfrm>
                  <a:off x="5663520" y="5544000"/>
                  <a:ext cx="9410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Eotaxin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5347080" y="5854680"/>
                  <a:ext cx="11073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RANTES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6093000" y="6101640"/>
                  <a:ext cx="0" cy="927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6453360" y="5792040"/>
                  <a:ext cx="0" cy="123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2" name=""/>
              <p:cNvGrpSpPr/>
              <p:nvPr/>
            </p:nvGrpSpPr>
            <p:grpSpPr>
              <a:xfrm>
                <a:off x="3791520" y="5853600"/>
                <a:ext cx="921240" cy="1175040"/>
                <a:chOff x="3791520" y="5853600"/>
                <a:chExt cx="921240" cy="1175040"/>
              </a:xfrm>
            </p:grpSpPr>
            <p:sp>
              <p:nvSpPr>
                <p:cNvPr id="103" name=""/>
                <p:cNvSpPr/>
                <p:nvPr/>
              </p:nvSpPr>
              <p:spPr>
                <a:xfrm>
                  <a:off x="3791520" y="5853600"/>
                  <a:ext cx="9212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CA" sz="1800" spc="-1" strike="noStrike">
                      <a:solidFill>
                        <a:srgbClr val="000000"/>
                      </a:solidFill>
                      <a:latin typeface="Arial"/>
                    </a:rPr>
                    <a:t>MIP-1</a:t>
                  </a:r>
                  <a:r>
                    <a:rPr b="0" lang="el-GR" sz="1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β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4251240" y="6101640"/>
                  <a:ext cx="0" cy="927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5" name=""/>
              <p:cNvGrpSpPr/>
              <p:nvPr/>
            </p:nvGrpSpPr>
            <p:grpSpPr>
              <a:xfrm>
                <a:off x="4758120" y="5542920"/>
                <a:ext cx="700560" cy="1486080"/>
                <a:chOff x="4758120" y="5542920"/>
                <a:chExt cx="700560" cy="1486080"/>
              </a:xfrm>
            </p:grpSpPr>
            <p:sp>
              <p:nvSpPr>
                <p:cNvPr id="106" name=""/>
                <p:cNvSpPr/>
                <p:nvPr/>
              </p:nvSpPr>
              <p:spPr>
                <a:xfrm>
                  <a:off x="4758120" y="5542920"/>
                  <a:ext cx="7005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IL-15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5084640" y="5790960"/>
                  <a:ext cx="23760" cy="123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8" name=""/>
              <p:cNvGrpSpPr/>
              <p:nvPr/>
            </p:nvGrpSpPr>
            <p:grpSpPr>
              <a:xfrm>
                <a:off x="3231000" y="7089120"/>
                <a:ext cx="3366000" cy="368280"/>
                <a:chOff x="3231000" y="7089120"/>
                <a:chExt cx="3366000" cy="368280"/>
              </a:xfrm>
            </p:grpSpPr>
            <p:sp>
              <p:nvSpPr>
                <p:cNvPr id="109" name=""/>
                <p:cNvSpPr/>
                <p:nvPr/>
              </p:nvSpPr>
              <p:spPr>
                <a:xfrm>
                  <a:off x="3231000" y="7089120"/>
                  <a:ext cx="8024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PMNs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6023160" y="7089120"/>
                  <a:ext cx="5738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Eos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4046400" y="7089120"/>
                  <a:ext cx="5540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M</a:t>
                  </a:r>
                  <a:r>
                    <a:rPr b="0" lang="el-GR" sz="1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Φ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4582080" y="7089120"/>
                  <a:ext cx="119556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Mast cells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3" name=""/>
            <p:cNvSpPr/>
            <p:nvPr/>
          </p:nvSpPr>
          <p:spPr>
            <a:xfrm>
              <a:off x="621720" y="6037920"/>
              <a:ext cx="61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I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H="1">
              <a:off x="1773360" y="222840"/>
              <a:ext cx="10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H="1">
              <a:off x="980640" y="222840"/>
              <a:ext cx="79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981000" y="222840"/>
              <a:ext cx="0" cy="1733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380960" y="6471720"/>
              <a:ext cx="0" cy="55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695520" y="7027920"/>
              <a:ext cx="13708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Th1 cel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liferatio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500280" y="222840"/>
              <a:ext cx="19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373720" y="222840"/>
              <a:ext cx="1295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" name=""/>
            <p:cNvGrpSpPr/>
            <p:nvPr/>
          </p:nvGrpSpPr>
          <p:grpSpPr>
            <a:xfrm>
              <a:off x="6643800" y="222840"/>
              <a:ext cx="0" cy="4516200"/>
              <a:chOff x="6643800" y="222840"/>
              <a:chExt cx="0" cy="4516200"/>
            </a:xfrm>
          </p:grpSpPr>
          <p:sp>
            <p:nvSpPr>
              <p:cNvPr id="122" name=""/>
              <p:cNvSpPr/>
              <p:nvPr/>
            </p:nvSpPr>
            <p:spPr>
              <a:xfrm>
                <a:off x="6643800" y="222840"/>
                <a:ext cx="0" cy="2893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6643800" y="3116520"/>
                <a:ext cx="0" cy="1622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4" name=""/>
            <p:cNvSpPr/>
            <p:nvPr/>
          </p:nvSpPr>
          <p:spPr>
            <a:xfrm flipH="1">
              <a:off x="4941720" y="4739760"/>
              <a:ext cx="1727280" cy="55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H="1">
              <a:off x="549000" y="2228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H="1">
              <a:off x="188640" y="22284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89000" y="222840"/>
              <a:ext cx="0" cy="358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89000" y="3810960"/>
              <a:ext cx="0" cy="86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89000" y="4677120"/>
              <a:ext cx="1224000" cy="9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141720" y="2512800"/>
              <a:ext cx="0" cy="309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51160" y="3254760"/>
              <a:ext cx="22122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Downstream IL-17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 u="sng">
                  <a:solidFill>
                    <a:srgbClr val="000000"/>
                  </a:solidFill>
                  <a:uFillTx/>
                  <a:latin typeface="Arial"/>
                </a:rPr>
                <a:t>Effector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49360" y="3193200"/>
              <a:ext cx="3671640" cy="1236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692280" y="7027920"/>
              <a:ext cx="1368360" cy="618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4" name=""/>
            <p:cNvGrpSpPr/>
            <p:nvPr/>
          </p:nvGrpSpPr>
          <p:grpSpPr>
            <a:xfrm>
              <a:off x="622440" y="4120560"/>
              <a:ext cx="802440" cy="862920"/>
              <a:chOff x="622440" y="4120560"/>
              <a:chExt cx="802440" cy="862920"/>
            </a:xfrm>
          </p:grpSpPr>
          <p:sp>
            <p:nvSpPr>
              <p:cNvPr id="135" name=""/>
              <p:cNvSpPr/>
              <p:nvPr/>
            </p:nvSpPr>
            <p:spPr>
              <a:xfrm>
                <a:off x="1023840" y="4120560"/>
                <a:ext cx="0" cy="49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622440" y="4615200"/>
                <a:ext cx="8024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PMN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7" name=""/>
            <p:cNvSpPr/>
            <p:nvPr/>
          </p:nvSpPr>
          <p:spPr>
            <a:xfrm>
              <a:off x="1701720" y="4615560"/>
              <a:ext cx="554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r>
                <a:rPr b="0" lang="el-GR" sz="1800" spc="-1" strike="noStrike">
                  <a:solidFill>
                    <a:srgbClr val="000000"/>
                  </a:solidFill>
                  <a:latin typeface="Arial"/>
                </a:rPr>
                <a:t>Φ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278800" y="4615560"/>
              <a:ext cx="1284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800" spc="-1" strike="noStrike">
                  <a:solidFill>
                    <a:srgbClr val="000000"/>
                  </a:solidFill>
                  <a:latin typeface="Arial"/>
                </a:rPr>
                <a:t>Monocy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916280" y="4120560"/>
              <a:ext cx="0" cy="49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924280" y="4120560"/>
              <a:ext cx="0" cy="49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H="1">
              <a:off x="6381360" y="3749400"/>
              <a:ext cx="14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6T02:55:19Z</dcterms:created>
  <dc:creator>Neil Sweezey</dc:creator>
  <dc:description/>
  <dc:language>en-US</dc:language>
  <cp:lastModifiedBy>Neil Sweezey</cp:lastModifiedBy>
  <dcterms:modified xsi:type="dcterms:W3CDTF">2010-11-24T04:46:06Z</dcterms:modified>
  <cp:revision>25</cp:revision>
  <dc:subject/>
  <dc:title>Slide 1</dc:title>
</cp:coreProperties>
</file>